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9" r:id="rId2"/>
    <p:sldId id="280" r:id="rId3"/>
    <p:sldId id="281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9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1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A47AC-1503-4D1E-BF0D-5A54C93634B2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76109C-E824-4F70-ABCE-35EB5E1770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894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6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0923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1604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018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132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011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663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9673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540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299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893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1680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5"/>
          <p:cNvSpPr txBox="1">
            <a:spLocks noChangeArrowheads="1"/>
          </p:cNvSpPr>
          <p:nvPr/>
        </p:nvSpPr>
        <p:spPr bwMode="auto">
          <a:xfrm>
            <a:off x="66839" y="49588"/>
            <a:ext cx="8928284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Supplementary Fig</a:t>
            </a:r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4. 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Efficacy of combined treatment with c-Met inhibitor and TRAIL in DDLPS PDCs.</a:t>
            </a:r>
            <a:endParaRPr lang="ko-KR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776905" y="1541983"/>
            <a:ext cx="346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8363" y="1924050"/>
            <a:ext cx="4867275" cy="300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82907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76905" y="1541983"/>
            <a:ext cx="346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-137" y="4554"/>
            <a:ext cx="254108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4</a:t>
            </a:r>
            <a:endParaRPr lang="ko-KR" altLang="en-US" sz="2000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8363" y="1914525"/>
            <a:ext cx="4867275" cy="3028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391666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76905" y="1541983"/>
            <a:ext cx="346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-3425" y="-15231"/>
            <a:ext cx="254108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4</a:t>
            </a:r>
            <a:endParaRPr lang="ko-KR" altLang="en-US" sz="2000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8363" y="1914525"/>
            <a:ext cx="4867275" cy="3028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8212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54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1</TotalTime>
  <Words>29</Words>
  <Application>Microsoft Office PowerPoint</Application>
  <PresentationFormat>화면 슬라이드 쇼(4:3)</PresentationFormat>
  <Paragraphs>6</Paragraphs>
  <Slides>3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RC 홍두표</dc:creator>
  <cp:lastModifiedBy>홍성민</cp:lastModifiedBy>
  <cp:revision>64</cp:revision>
  <dcterms:created xsi:type="dcterms:W3CDTF">2018-11-08T23:08:45Z</dcterms:created>
  <dcterms:modified xsi:type="dcterms:W3CDTF">2019-04-07T14:23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D:\홍두표 박사님\메추라기\Mouse sarcoma model\PDX\trail cmet figure\revision\BCAND18 REVISION 181109.pptx</vt:lpwstr>
  </property>
</Properties>
</file>